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53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aper\KIOST\Haliclona\20150516_CCK-8_Rawcell_1304KO328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76730138032109"/>
          <c:y val="5.1400606624460117E-2"/>
          <c:w val="0.80284244724186549"/>
          <c:h val="0.75769059126975125"/>
        </c:manualLayout>
      </c:layout>
      <c:scatterChart>
        <c:scatterStyle val="lineMarker"/>
        <c:varyColors val="0"/>
        <c:ser>
          <c:idx val="0"/>
          <c:order val="0"/>
          <c:tx>
            <c:strRef>
              <c:f>graph!$B$3:$G$3</c:f>
              <c:strCache>
                <c:ptCount val="1"/>
                <c:pt idx="0">
                  <c:v>24 h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8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graph!$B$24:$G$24</c:f>
                <c:numCache>
                  <c:formatCode>General</c:formatCode>
                  <c:ptCount val="6"/>
                  <c:pt idx="1">
                    <c:v>1.6255096404135061</c:v>
                  </c:pt>
                  <c:pt idx="2">
                    <c:v>1.5577492865594891</c:v>
                  </c:pt>
                  <c:pt idx="3">
                    <c:v>1.5597013050604283</c:v>
                  </c:pt>
                  <c:pt idx="4">
                    <c:v>1.5974906868808816</c:v>
                  </c:pt>
                  <c:pt idx="5">
                    <c:v>3.01814810973212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graph!$B$4:$G$4</c:f>
              <c:numCache>
                <c:formatCode>General</c:formatCode>
                <c:ptCount val="6"/>
                <c:pt idx="0">
                  <c:v>0</c:v>
                </c:pt>
                <c:pt idx="1">
                  <c:v>6.25</c:v>
                </c:pt>
                <c:pt idx="2">
                  <c:v>12.5</c:v>
                </c:pt>
                <c:pt idx="3">
                  <c:v>25</c:v>
                </c:pt>
                <c:pt idx="4">
                  <c:v>50</c:v>
                </c:pt>
                <c:pt idx="5">
                  <c:v>100</c:v>
                </c:pt>
              </c:numCache>
            </c:numRef>
          </c:xVal>
          <c:yVal>
            <c:numRef>
              <c:f>graph!$B$23:$G$23</c:f>
              <c:numCache>
                <c:formatCode>General</c:formatCode>
                <c:ptCount val="6"/>
                <c:pt idx="0">
                  <c:v>100</c:v>
                </c:pt>
                <c:pt idx="1">
                  <c:v>100.87295945357765</c:v>
                </c:pt>
                <c:pt idx="2">
                  <c:v>101.43468570241012</c:v>
                </c:pt>
                <c:pt idx="3">
                  <c:v>101.54618498694062</c:v>
                </c:pt>
                <c:pt idx="4">
                  <c:v>101.49462739683987</c:v>
                </c:pt>
                <c:pt idx="5">
                  <c:v>97.9353154866438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graph!$H$3:$M$3</c:f>
              <c:strCache>
                <c:ptCount val="1"/>
                <c:pt idx="0">
                  <c:v>48 h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8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graph!$H$24:$M$24</c:f>
                <c:numCache>
                  <c:formatCode>General</c:formatCode>
                  <c:ptCount val="6"/>
                  <c:pt idx="1">
                    <c:v>1.4117557235664533</c:v>
                  </c:pt>
                  <c:pt idx="2">
                    <c:v>1.4341206057770126</c:v>
                  </c:pt>
                  <c:pt idx="3">
                    <c:v>1.3499581281187594</c:v>
                  </c:pt>
                  <c:pt idx="4">
                    <c:v>2.9390846639590191</c:v>
                  </c:pt>
                  <c:pt idx="5">
                    <c:v>5.712324007669261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graph!$B$4:$G$4</c:f>
              <c:numCache>
                <c:formatCode>General</c:formatCode>
                <c:ptCount val="6"/>
                <c:pt idx="0">
                  <c:v>0</c:v>
                </c:pt>
                <c:pt idx="1">
                  <c:v>6.25</c:v>
                </c:pt>
                <c:pt idx="2">
                  <c:v>12.5</c:v>
                </c:pt>
                <c:pt idx="3">
                  <c:v>25</c:v>
                </c:pt>
                <c:pt idx="4">
                  <c:v>50</c:v>
                </c:pt>
                <c:pt idx="5">
                  <c:v>100</c:v>
                </c:pt>
              </c:numCache>
            </c:numRef>
          </c:xVal>
          <c:yVal>
            <c:numRef>
              <c:f>graph!$H$23:$M$23</c:f>
              <c:numCache>
                <c:formatCode>General</c:formatCode>
                <c:ptCount val="6"/>
                <c:pt idx="0">
                  <c:v>100</c:v>
                </c:pt>
                <c:pt idx="1">
                  <c:v>99.687702288296393</c:v>
                </c:pt>
                <c:pt idx="2">
                  <c:v>98.553332635271715</c:v>
                </c:pt>
                <c:pt idx="3">
                  <c:v>99.159609799890305</c:v>
                </c:pt>
                <c:pt idx="4">
                  <c:v>99.175248013373803</c:v>
                </c:pt>
                <c:pt idx="5">
                  <c:v>91.32402546639551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4708224"/>
        <c:axId val="24710144"/>
      </c:scatterChart>
      <c:valAx>
        <c:axId val="24708224"/>
        <c:scaling>
          <c:orientation val="minMax"/>
          <c:max val="105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Concentration (</a:t>
                </a:r>
                <a:r>
                  <a:rPr lang="en-US">
                    <a:latin typeface="Symbol" pitchFamily="18" charset="2"/>
                  </a:rPr>
                  <a:t>m</a:t>
                </a:r>
                <a:r>
                  <a:rPr lang="en-US"/>
                  <a:t>g/ml)</a:t>
                </a:r>
              </a:p>
            </c:rich>
          </c:tx>
          <c:layout>
            <c:manualLayout>
              <c:xMode val="edge"/>
              <c:yMode val="edge"/>
              <c:x val="0.32961086870510614"/>
              <c:y val="0.9134269743659564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24710144"/>
        <c:crosses val="autoZero"/>
        <c:crossBetween val="midCat"/>
        <c:majorUnit val="20"/>
      </c:valAx>
      <c:valAx>
        <c:axId val="24710144"/>
        <c:scaling>
          <c:orientation val="minMax"/>
          <c:max val="11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ell viability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4708224"/>
        <c:crossesAt val="0"/>
        <c:crossBetween val="midCat"/>
      </c:valAx>
      <c:spPr>
        <a:noFill/>
        <a:ln>
          <a:noFill/>
        </a:ln>
      </c:spPr>
    </c:plotArea>
    <c:legend>
      <c:legendPos val="r"/>
      <c:layout>
        <c:manualLayout>
          <c:xMode val="edge"/>
          <c:yMode val="edge"/>
          <c:x val="0.15909390307103338"/>
          <c:y val="0.51120863494368673"/>
          <c:w val="0.17565485842932052"/>
          <c:h val="0.18507522294583495"/>
        </c:manualLayout>
      </c:layout>
      <c:overlay val="0"/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200"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4872D-BFD9-49A8-9266-414257D55BFE}" type="datetimeFigureOut">
              <a:rPr lang="ko-KR" altLang="en-US" smtClean="0"/>
              <a:t>2015-06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28134-969F-4DC5-A0B4-10D231614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4363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4872D-BFD9-49A8-9266-414257D55BFE}" type="datetimeFigureOut">
              <a:rPr lang="ko-KR" altLang="en-US" smtClean="0"/>
              <a:t>2015-06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28134-969F-4DC5-A0B4-10D231614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30786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4872D-BFD9-49A8-9266-414257D55BFE}" type="datetimeFigureOut">
              <a:rPr lang="ko-KR" altLang="en-US" smtClean="0"/>
              <a:t>2015-06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28134-969F-4DC5-A0B4-10D231614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1928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4872D-BFD9-49A8-9266-414257D55BFE}" type="datetimeFigureOut">
              <a:rPr lang="ko-KR" altLang="en-US" smtClean="0"/>
              <a:t>2015-06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28134-969F-4DC5-A0B4-10D231614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1539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4872D-BFD9-49A8-9266-414257D55BFE}" type="datetimeFigureOut">
              <a:rPr lang="ko-KR" altLang="en-US" smtClean="0"/>
              <a:t>2015-06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28134-969F-4DC5-A0B4-10D231614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5040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4872D-BFD9-49A8-9266-414257D55BFE}" type="datetimeFigureOut">
              <a:rPr lang="ko-KR" altLang="en-US" smtClean="0"/>
              <a:t>2015-06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28134-969F-4DC5-A0B4-10D231614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01353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4872D-BFD9-49A8-9266-414257D55BFE}" type="datetimeFigureOut">
              <a:rPr lang="ko-KR" altLang="en-US" smtClean="0"/>
              <a:t>2015-06-0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28134-969F-4DC5-A0B4-10D231614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6870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4872D-BFD9-49A8-9266-414257D55BFE}" type="datetimeFigureOut">
              <a:rPr lang="ko-KR" altLang="en-US" smtClean="0"/>
              <a:t>2015-06-0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28134-969F-4DC5-A0B4-10D231614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6657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4872D-BFD9-49A8-9266-414257D55BFE}" type="datetimeFigureOut">
              <a:rPr lang="ko-KR" altLang="en-US" smtClean="0"/>
              <a:t>2015-06-0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28134-969F-4DC5-A0B4-10D231614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47282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4872D-BFD9-49A8-9266-414257D55BFE}" type="datetimeFigureOut">
              <a:rPr lang="ko-KR" altLang="en-US" smtClean="0"/>
              <a:t>2015-06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28134-969F-4DC5-A0B4-10D231614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3980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4872D-BFD9-49A8-9266-414257D55BFE}" type="datetimeFigureOut">
              <a:rPr lang="ko-KR" altLang="en-US" smtClean="0"/>
              <a:t>2015-06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28134-969F-4DC5-A0B4-10D231614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7739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84872D-BFD9-49A8-9266-414257D55BFE}" type="datetimeFigureOut">
              <a:rPr lang="ko-KR" altLang="en-US" smtClean="0"/>
              <a:t>2015-06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928134-969F-4DC5-A0B4-10D231614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0331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차트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2321138"/>
              </p:ext>
            </p:extLst>
          </p:nvPr>
        </p:nvGraphicFramePr>
        <p:xfrm>
          <a:off x="1893457" y="404664"/>
          <a:ext cx="5328592" cy="3960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11076" y="4653136"/>
            <a:ext cx="869335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Supplemental data 1. 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Cell viability of </a:t>
            </a:r>
            <a:r>
              <a:rPr lang="en-US" altLang="ko-KR" b="1" i="1" dirty="0" smtClean="0">
                <a:latin typeface="Times New Roman" pitchFamily="18" charset="0"/>
                <a:cs typeface="Times New Roman" pitchFamily="18" charset="0"/>
              </a:rPr>
              <a:t>Haliclona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 sp. extract in 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Raw264.7 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cells </a:t>
            </a:r>
          </a:p>
          <a:p>
            <a:pPr>
              <a:lnSpc>
                <a:spcPct val="150000"/>
              </a:lnSpc>
            </a:pPr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 Mouse monocyte Raw264.7 cells were seeded in 96-well plate and treated with </a:t>
            </a:r>
            <a:r>
              <a:rPr lang="en-US" altLang="ko-KR" i="1" dirty="0" err="1" smtClean="0">
                <a:latin typeface="Times New Roman" pitchFamily="18" charset="0"/>
                <a:cs typeface="Times New Roman" pitchFamily="18" charset="0"/>
              </a:rPr>
              <a:t>Haliclona</a:t>
            </a:r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 sp. extracts for 24 h or 48 h. Cell viability was determined by cell counting kit-8 assay (n=8). </a:t>
            </a:r>
          </a:p>
          <a:p>
            <a:pPr>
              <a:lnSpc>
                <a:spcPct val="150000"/>
              </a:lnSpc>
            </a:pPr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The data showed mean ± standard deviation. </a:t>
            </a:r>
            <a:endParaRPr lang="en-US" altLang="ko-KR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51595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65</Words>
  <Application>Microsoft Office PowerPoint</Application>
  <PresentationFormat>화면 슬라이드 쇼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Company>DuksungWomen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ung</dc:creator>
  <cp:lastModifiedBy>Jung</cp:lastModifiedBy>
  <cp:revision>1</cp:revision>
  <dcterms:created xsi:type="dcterms:W3CDTF">2015-06-07T16:29:08Z</dcterms:created>
  <dcterms:modified xsi:type="dcterms:W3CDTF">2015-06-07T16:35:48Z</dcterms:modified>
</cp:coreProperties>
</file>